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669088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5" d="100"/>
          <a:sy n="85" d="100"/>
        </p:scale>
        <p:origin x="292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3C6A2-32D0-43EE-9E7D-1BECEF03B516}" type="datetimeFigureOut">
              <a:rPr lang="fr-FR" smtClean="0"/>
              <a:t>01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772AE-E0BE-4F39-A223-99D330B715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41190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3C6A2-32D0-43EE-9E7D-1BECEF03B516}" type="datetimeFigureOut">
              <a:rPr lang="fr-FR" smtClean="0"/>
              <a:t>01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772AE-E0BE-4F39-A223-99D330B715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144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3C6A2-32D0-43EE-9E7D-1BECEF03B516}" type="datetimeFigureOut">
              <a:rPr lang="fr-FR" smtClean="0"/>
              <a:t>01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772AE-E0BE-4F39-A223-99D330B715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90721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3C6A2-32D0-43EE-9E7D-1BECEF03B516}" type="datetimeFigureOut">
              <a:rPr lang="fr-FR" smtClean="0"/>
              <a:t>01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772AE-E0BE-4F39-A223-99D330B715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66223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3C6A2-32D0-43EE-9E7D-1BECEF03B516}" type="datetimeFigureOut">
              <a:rPr lang="fr-FR" smtClean="0"/>
              <a:t>01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772AE-E0BE-4F39-A223-99D330B715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04876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3C6A2-32D0-43EE-9E7D-1BECEF03B516}" type="datetimeFigureOut">
              <a:rPr lang="fr-FR" smtClean="0"/>
              <a:t>01/04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772AE-E0BE-4F39-A223-99D330B715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00770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3C6A2-32D0-43EE-9E7D-1BECEF03B516}" type="datetimeFigureOut">
              <a:rPr lang="fr-FR" smtClean="0"/>
              <a:t>01/04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772AE-E0BE-4F39-A223-99D330B715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41913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3C6A2-32D0-43EE-9E7D-1BECEF03B516}" type="datetimeFigureOut">
              <a:rPr lang="fr-FR" smtClean="0"/>
              <a:t>01/04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772AE-E0BE-4F39-A223-99D330B715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78220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3C6A2-32D0-43EE-9E7D-1BECEF03B516}" type="datetimeFigureOut">
              <a:rPr lang="fr-FR" smtClean="0"/>
              <a:t>01/04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772AE-E0BE-4F39-A223-99D330B715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1031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3C6A2-32D0-43EE-9E7D-1BECEF03B516}" type="datetimeFigureOut">
              <a:rPr lang="fr-FR" smtClean="0"/>
              <a:t>01/04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772AE-E0BE-4F39-A223-99D330B715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867156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3C6A2-32D0-43EE-9E7D-1BECEF03B516}" type="datetimeFigureOut">
              <a:rPr lang="fr-FR" smtClean="0"/>
              <a:t>01/04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772AE-E0BE-4F39-A223-99D330B715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997287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B3C6A2-32D0-43EE-9E7D-1BECEF03B516}" type="datetimeFigureOut">
              <a:rPr lang="fr-FR" smtClean="0"/>
              <a:t>01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D772AE-E0BE-4F39-A223-99D330B715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0797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3767" y="2979668"/>
            <a:ext cx="5495925" cy="431617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291328" y="2933897"/>
            <a:ext cx="590226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500" b="1"/>
              <a:t>9574</a:t>
            </a:r>
          </a:p>
          <a:p>
            <a:pPr algn="r"/>
            <a:r>
              <a:rPr lang="fr-FR" sz="500" b="1"/>
              <a:t>18/199</a:t>
            </a:r>
          </a:p>
          <a:p>
            <a:pPr algn="r"/>
            <a:r>
              <a:rPr lang="fr-FR" sz="500" b="1"/>
              <a:t>16/65</a:t>
            </a:r>
          </a:p>
          <a:p>
            <a:pPr algn="r"/>
            <a:r>
              <a:rPr lang="fr-FR" sz="500" b="1"/>
              <a:t>PRV (this work)</a:t>
            </a:r>
          </a:p>
          <a:p>
            <a:pPr algn="r"/>
            <a:r>
              <a:rPr lang="fr-FR" sz="500" b="1"/>
              <a:t>PRV (</a:t>
            </a:r>
            <a:r>
              <a:rPr lang="fr-FR" sz="500" b="1" smtClean="0"/>
              <a:t>JX679246)</a:t>
            </a:r>
            <a:endParaRPr lang="fr-FR" sz="500" b="1"/>
          </a:p>
        </p:txBody>
      </p:sp>
      <p:sp>
        <p:nvSpPr>
          <p:cNvPr id="7" name="ZoneTexte 6"/>
          <p:cNvSpPr txBox="1"/>
          <p:nvPr/>
        </p:nvSpPr>
        <p:spPr>
          <a:xfrm>
            <a:off x="307331" y="3573233"/>
            <a:ext cx="61020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ure S2</a:t>
            </a:r>
            <a:r>
              <a:rPr lang="en-US" sz="1200" dirty="0"/>
              <a:t>. Comparison of portions of the RNA polymerase (</a:t>
            </a:r>
            <a:r>
              <a:rPr lang="en-US" sz="1200" i="1" dirty="0"/>
              <a:t>l</a:t>
            </a:r>
            <a:r>
              <a:rPr lang="en-US" sz="1200" dirty="0"/>
              <a:t>)</a:t>
            </a:r>
            <a:r>
              <a:rPr lang="en-US" sz="1200" i="1" dirty="0"/>
              <a:t> </a:t>
            </a:r>
            <a:r>
              <a:rPr lang="en-US" sz="1200" dirty="0"/>
              <a:t>gene of related viruses. Note the differences between </a:t>
            </a:r>
            <a:r>
              <a:rPr lang="en-US" sz="1200"/>
              <a:t>the </a:t>
            </a:r>
            <a:r>
              <a:rPr lang="en-US" sz="1200" smtClean="0"/>
              <a:t>full-length </a:t>
            </a:r>
            <a:r>
              <a:rPr lang="en-US" sz="1200"/>
              <a:t>PRV </a:t>
            </a:r>
            <a:r>
              <a:rPr lang="en-US" sz="1200" smtClean="0"/>
              <a:t>sequence published by others </a:t>
            </a:r>
            <a:r>
              <a:rPr lang="en-US" sz="1200" dirty="0"/>
              <a:t>(JX679246) and our own sequences of the same or other isolates.</a:t>
            </a:r>
          </a:p>
        </p:txBody>
      </p:sp>
    </p:spTree>
    <p:extLst>
      <p:ext uri="{BB962C8B-B14F-4D97-AF65-F5344CB8AC3E}">
        <p14:creationId xmlns:p14="http://schemas.microsoft.com/office/powerpoint/2010/main" val="26163457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</TotalTime>
  <Words>55</Words>
  <Application>Microsoft Office PowerPoint</Application>
  <PresentationFormat>Affichage à l'écran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ANS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IGARRE Laurent</dc:creator>
  <cp:lastModifiedBy>BIGARRE Laurent</cp:lastModifiedBy>
  <cp:revision>14</cp:revision>
  <cp:lastPrinted>2020-03-13T13:26:32Z</cp:lastPrinted>
  <dcterms:created xsi:type="dcterms:W3CDTF">2020-03-04T08:49:55Z</dcterms:created>
  <dcterms:modified xsi:type="dcterms:W3CDTF">2020-04-01T09:01:01Z</dcterms:modified>
</cp:coreProperties>
</file>